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4">
  <p:sldMasterIdLst>
    <p:sldMasterId id="2147483660" r:id="rId1"/>
  </p:sldMasterIdLst>
  <p:notesMasterIdLst>
    <p:notesMasterId r:id="rId20"/>
  </p:notesMasterIdLst>
  <p:sldIdLst>
    <p:sldId id="257" r:id="rId2"/>
    <p:sldId id="281" r:id="rId3"/>
    <p:sldId id="276" r:id="rId4"/>
    <p:sldId id="297" r:id="rId5"/>
    <p:sldId id="302" r:id="rId6"/>
    <p:sldId id="280" r:id="rId7"/>
    <p:sldId id="294" r:id="rId8"/>
    <p:sldId id="287" r:id="rId9"/>
    <p:sldId id="288" r:id="rId10"/>
    <p:sldId id="271" r:id="rId11"/>
    <p:sldId id="285" r:id="rId12"/>
    <p:sldId id="258" r:id="rId13"/>
    <p:sldId id="284" r:id="rId14"/>
    <p:sldId id="279" r:id="rId15"/>
    <p:sldId id="283" r:id="rId16"/>
    <p:sldId id="301" r:id="rId17"/>
    <p:sldId id="298" r:id="rId18"/>
    <p:sldId id="300" r:id="rId19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56A5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29" autoAdjust="0"/>
    <p:restoredTop sz="95159" autoAdjust="0"/>
  </p:normalViewPr>
  <p:slideViewPr>
    <p:cSldViewPr snapToGrid="0" snapToObjects="1">
      <p:cViewPr varScale="1">
        <p:scale>
          <a:sx n="158" d="100"/>
          <a:sy n="158" d="100"/>
        </p:scale>
        <p:origin x="192" y="22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0E7029-4F54-4EDE-AD18-5EDFD7E5049C}" type="datetimeFigureOut">
              <a:rPr lang="en-US" smtClean="0"/>
              <a:t>4/2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84A80B-B42E-4951-BC92-0E2A590555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698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4A80B-B42E-4951-BC92-0E2A5905554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6561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4A80B-B42E-4951-BC92-0E2A5905554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3529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4A80B-B42E-4951-BC92-0E2A5905554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003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4A80B-B42E-4951-BC92-0E2A5905554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5384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DC8A4-A788-FA47-8753-A75E9926F4AD}" type="datetimeFigureOut">
              <a:rPr lang="en-US" smtClean="0"/>
              <a:t>4/2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427C9-A833-714C-9A1C-56A1582995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677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3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6.png"/><Relationship Id="rId12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image" Target="../media/image8.png"/><Relationship Id="rId5" Type="http://schemas.openxmlformats.org/officeDocument/2006/relationships/image" Target="../media/image1.emf"/><Relationship Id="rId15" Type="http://schemas.openxmlformats.org/officeDocument/2006/relationships/image" Target="../media/image4.emf"/><Relationship Id="rId10" Type="http://schemas.openxmlformats.org/officeDocument/2006/relationships/image" Target="../media/image2.emf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2.bin"/><Relationship Id="rId14" Type="http://schemas.openxmlformats.org/officeDocument/2006/relationships/oleObject" Target="../embeddings/oleObject4.bin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jpeg"/><Relationship Id="rId2" Type="http://schemas.openxmlformats.org/officeDocument/2006/relationships/image" Target="../media/image5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8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emf"/><Relationship Id="rId3" Type="http://schemas.openxmlformats.org/officeDocument/2006/relationships/image" Target="../media/image60.emf"/><Relationship Id="rId7" Type="http://schemas.openxmlformats.org/officeDocument/2006/relationships/image" Target="../media/image64.emf"/><Relationship Id="rId12" Type="http://schemas.openxmlformats.org/officeDocument/2006/relationships/image" Target="../media/image69.tiff"/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emf"/><Relationship Id="rId11" Type="http://schemas.openxmlformats.org/officeDocument/2006/relationships/image" Target="../media/image68.png"/><Relationship Id="rId5" Type="http://schemas.openxmlformats.org/officeDocument/2006/relationships/image" Target="../media/image62.emf"/><Relationship Id="rId10" Type="http://schemas.openxmlformats.org/officeDocument/2006/relationships/image" Target="../media/image67.png"/><Relationship Id="rId4" Type="http://schemas.openxmlformats.org/officeDocument/2006/relationships/image" Target="../media/image61.emf"/><Relationship Id="rId9" Type="http://schemas.openxmlformats.org/officeDocument/2006/relationships/image" Target="../media/image66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jpeg"/><Relationship Id="rId3" Type="http://schemas.openxmlformats.org/officeDocument/2006/relationships/image" Target="../media/image70.emf"/><Relationship Id="rId7" Type="http://schemas.openxmlformats.org/officeDocument/2006/relationships/image" Target="../media/image7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3.emf"/><Relationship Id="rId5" Type="http://schemas.openxmlformats.org/officeDocument/2006/relationships/image" Target="../media/image72.emf"/><Relationship Id="rId4" Type="http://schemas.openxmlformats.org/officeDocument/2006/relationships/image" Target="../media/image71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emf"/><Relationship Id="rId13" Type="http://schemas.openxmlformats.org/officeDocument/2006/relationships/image" Target="../media/image88.emf"/><Relationship Id="rId3" Type="http://schemas.openxmlformats.org/officeDocument/2006/relationships/image" Target="../media/image78.png"/><Relationship Id="rId7" Type="http://schemas.openxmlformats.org/officeDocument/2006/relationships/image" Target="../media/image82.png"/><Relationship Id="rId12" Type="http://schemas.openxmlformats.org/officeDocument/2006/relationships/image" Target="../media/image8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1.jpeg"/><Relationship Id="rId11" Type="http://schemas.openxmlformats.org/officeDocument/2006/relationships/image" Target="../media/image86.jpeg"/><Relationship Id="rId5" Type="http://schemas.openxmlformats.org/officeDocument/2006/relationships/image" Target="../media/image80.png"/><Relationship Id="rId10" Type="http://schemas.openxmlformats.org/officeDocument/2006/relationships/image" Target="../media/image85.tiff"/><Relationship Id="rId4" Type="http://schemas.openxmlformats.org/officeDocument/2006/relationships/image" Target="../media/image79.jpeg"/><Relationship Id="rId9" Type="http://schemas.openxmlformats.org/officeDocument/2006/relationships/image" Target="../media/image84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0.jpeg"/><Relationship Id="rId2" Type="http://schemas.openxmlformats.org/officeDocument/2006/relationships/image" Target="../media/image8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2.png"/><Relationship Id="rId4" Type="http://schemas.openxmlformats.org/officeDocument/2006/relationships/image" Target="../media/image91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png"/><Relationship Id="rId2" Type="http://schemas.openxmlformats.org/officeDocument/2006/relationships/image" Target="../media/image9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5.pn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6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13" Type="http://schemas.openxmlformats.org/officeDocument/2006/relationships/image" Target="../media/image20.emf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em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11" Type="http://schemas.openxmlformats.org/officeDocument/2006/relationships/image" Target="../media/image18.tiff"/><Relationship Id="rId5" Type="http://schemas.openxmlformats.org/officeDocument/2006/relationships/image" Target="../media/image12.jpeg"/><Relationship Id="rId10" Type="http://schemas.openxmlformats.org/officeDocument/2006/relationships/image" Target="../media/image17.tiff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eg"/><Relationship Id="rId5" Type="http://schemas.openxmlformats.org/officeDocument/2006/relationships/image" Target="../media/image27.jpeg"/><Relationship Id="rId4" Type="http://schemas.openxmlformats.org/officeDocument/2006/relationships/image" Target="../media/image26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tiff"/><Relationship Id="rId7" Type="http://schemas.openxmlformats.org/officeDocument/2006/relationships/image" Target="../media/image3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jpeg"/><Relationship Id="rId11" Type="http://schemas.openxmlformats.org/officeDocument/2006/relationships/image" Target="../media/image37.emf"/><Relationship Id="rId5" Type="http://schemas.openxmlformats.org/officeDocument/2006/relationships/image" Target="../media/image31.jpeg"/><Relationship Id="rId10" Type="http://schemas.openxmlformats.org/officeDocument/2006/relationships/image" Target="../media/image36.png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image" Target="../media/image39.tiff"/><Relationship Id="rId7" Type="http://schemas.openxmlformats.org/officeDocument/2006/relationships/image" Target="../media/image43.emf"/><Relationship Id="rId2" Type="http://schemas.openxmlformats.org/officeDocument/2006/relationships/image" Target="../media/image3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jpeg"/><Relationship Id="rId5" Type="http://schemas.openxmlformats.org/officeDocument/2006/relationships/image" Target="../media/image41.jpeg"/><Relationship Id="rId10" Type="http://schemas.openxmlformats.org/officeDocument/2006/relationships/image" Target="../media/image46.emf"/><Relationship Id="rId4" Type="http://schemas.openxmlformats.org/officeDocument/2006/relationships/image" Target="../media/image40.emf"/><Relationship Id="rId9" Type="http://schemas.openxmlformats.org/officeDocument/2006/relationships/image" Target="../media/image4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1344412"/>
              </p:ext>
            </p:extLst>
          </p:nvPr>
        </p:nvGraphicFramePr>
        <p:xfrm>
          <a:off x="3954434" y="63901"/>
          <a:ext cx="2210015" cy="2160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26" r:id="rId4" imgW="4546353" imgH="4491481" progId="Prism6.Document">
                  <p:embed/>
                </p:oleObj>
              </mc:Choice>
              <mc:Fallback>
                <p:oleObj r:id="rId4" imgW="4546353" imgH="449148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54434" y="63901"/>
                        <a:ext cx="2210015" cy="216090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9" name="Picture 18"/>
          <p:cNvPicPr/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1462"/>
          <a:stretch/>
        </p:blipFill>
        <p:spPr bwMode="auto">
          <a:xfrm>
            <a:off x="3904164" y="6620732"/>
            <a:ext cx="2616141" cy="2176041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TextBox 19"/>
          <p:cNvSpPr txBox="1"/>
          <p:nvPr/>
        </p:nvSpPr>
        <p:spPr>
          <a:xfrm>
            <a:off x="136035" y="18306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pic>
        <p:nvPicPr>
          <p:cNvPr id="21" name="Picture 20"/>
          <p:cNvPicPr/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068847" y="4681869"/>
            <a:ext cx="2191178" cy="1916133"/>
          </a:xfrm>
          <a:prstGeom prst="rect">
            <a:avLst/>
          </a:prstGeom>
          <a:noFill/>
        </p:spPr>
      </p:pic>
      <p:pic>
        <p:nvPicPr>
          <p:cNvPr id="22" name="Picture 21"/>
          <p:cNvPicPr/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99043" y="4657371"/>
            <a:ext cx="2161057" cy="1856873"/>
          </a:xfrm>
          <a:prstGeom prst="rect">
            <a:avLst/>
          </a:prstGeom>
          <a:noFill/>
        </p:spPr>
      </p:pic>
      <p:sp>
        <p:nvSpPr>
          <p:cNvPr id="23" name="TextBox 22"/>
          <p:cNvSpPr txBox="1"/>
          <p:nvPr/>
        </p:nvSpPr>
        <p:spPr>
          <a:xfrm>
            <a:off x="136035" y="211928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759147" y="14812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3297273"/>
              </p:ext>
            </p:extLst>
          </p:nvPr>
        </p:nvGraphicFramePr>
        <p:xfrm>
          <a:off x="618648" y="-15064"/>
          <a:ext cx="2825750" cy="2224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27" r:id="rId9" imgW="5159304" imgH="3906231" progId="Prism6.Document">
                  <p:embed/>
                </p:oleObj>
              </mc:Choice>
              <mc:Fallback>
                <p:oleObj r:id="rId9" imgW="5159304" imgH="3906231" progId="Prism6.Document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8648" y="-15064"/>
                        <a:ext cx="2825750" cy="22240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528630" y="4429583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RWPE1</a:t>
            </a:r>
            <a:endParaRPr lang="en-US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955823" y="4429583"/>
            <a:ext cx="5565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NCaP</a:t>
            </a:r>
            <a:endParaRPr lang="en-US" b="1" dirty="0"/>
          </a:p>
        </p:txBody>
      </p:sp>
      <p:grpSp>
        <p:nvGrpSpPr>
          <p:cNvPr id="24" name="Group 23"/>
          <p:cNvGrpSpPr/>
          <p:nvPr/>
        </p:nvGrpSpPr>
        <p:grpSpPr>
          <a:xfrm>
            <a:off x="578850" y="6582064"/>
            <a:ext cx="2588344" cy="2346407"/>
            <a:chOff x="4512425" y="1231784"/>
            <a:chExt cx="2758549" cy="2839058"/>
          </a:xfrm>
        </p:grpSpPr>
        <p:pic>
          <p:nvPicPr>
            <p:cNvPr id="25" name="Picture 24"/>
            <p:cNvPicPr/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512425" y="1318291"/>
              <a:ext cx="2758549" cy="27525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>
              <a:off x="4959116" y="1231784"/>
              <a:ext cx="394985" cy="300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3" dirty="0"/>
                <a:t>*  *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73415" y="1248020"/>
              <a:ext cx="370614" cy="248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3" dirty="0"/>
                <a:t>*  *</a:t>
              </a:r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4318552" y="6603599"/>
            <a:ext cx="347747" cy="205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*  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2031523" y="876541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</a:t>
            </a: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4963678"/>
              </p:ext>
            </p:extLst>
          </p:nvPr>
        </p:nvGraphicFramePr>
        <p:xfrm>
          <a:off x="562244" y="2152136"/>
          <a:ext cx="2500062" cy="21906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28" r:id="rId12" imgW="4546353" imgH="4326891" progId="Prism6.Document">
                  <p:embed/>
                </p:oleObj>
              </mc:Choice>
              <mc:Fallback>
                <p:oleObj r:id="rId12" imgW="4546353" imgH="432689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2244" y="2152136"/>
                        <a:ext cx="2500062" cy="21906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7" name="Group 36"/>
          <p:cNvGrpSpPr/>
          <p:nvPr/>
        </p:nvGrpSpPr>
        <p:grpSpPr>
          <a:xfrm>
            <a:off x="3483338" y="228510"/>
            <a:ext cx="2799237" cy="4200250"/>
            <a:chOff x="2627519" y="114768"/>
            <a:chExt cx="2799237" cy="4200250"/>
          </a:xfrm>
        </p:grpSpPr>
        <p:graphicFrame>
          <p:nvGraphicFramePr>
            <p:cNvPr id="38" name="Object 3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80001"/>
                </p:ext>
              </p:extLst>
            </p:nvPr>
          </p:nvGraphicFramePr>
          <p:xfrm>
            <a:off x="3064793" y="2005544"/>
            <a:ext cx="2361963" cy="23094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29" r:id="rId14" imgW="4546353" imgH="4436738" progId="Prism6.Document">
                    <p:embed/>
                  </p:oleObj>
                </mc:Choice>
                <mc:Fallback>
                  <p:oleObj r:id="rId14" imgW="4546353" imgH="4436738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064793" y="2005544"/>
                          <a:ext cx="2361963" cy="2309474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Rectangle 38"/>
            <p:cNvSpPr/>
            <p:nvPr/>
          </p:nvSpPr>
          <p:spPr>
            <a:xfrm>
              <a:off x="2627519" y="114768"/>
              <a:ext cx="1805545" cy="33706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133585" y="453182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594464" y="15071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564036" y="211928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582108" y="4513284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647989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967539" y="8622904"/>
            <a:ext cx="2839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0 </a:t>
            </a:r>
          </a:p>
        </p:txBody>
      </p:sp>
      <p:pic>
        <p:nvPicPr>
          <p:cNvPr id="17" name="Picture 2" descr="\\CancerGenetics\CG$\SmiragliaLab\Mark Long\Projects\RARg and miR-96-182-183\manuscript\Figs\PCa GEMMs_ Rarg.tif"/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227929" y="590338"/>
            <a:ext cx="4715671" cy="4419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8" descr="\\CancerGenetics\CG$\SmiragliaLab\Mark Long\Projects\RARg and miR-96-182-183\manuscript\Figs\TRAMP_mir-182_RARG.jpg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022593" y="5573226"/>
            <a:ext cx="2271965" cy="25098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9" descr="\\CancerGenetics\CG$\SmiragliaLab\Mark Long\Projects\RARg and miR-96-182-183\manuscript\Figs\TRAMP_mir-183_RARG.jpg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387158" y="5461164"/>
            <a:ext cx="2244040" cy="2710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021009" y="59033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18229" y="516108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813088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2810" y="360261"/>
            <a:ext cx="6980409" cy="2660524"/>
            <a:chOff x="-195921" y="1530303"/>
            <a:chExt cx="8508283" cy="3428334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649" t="7112" b="16652"/>
            <a:stretch/>
          </p:blipFill>
          <p:spPr bwMode="auto">
            <a:xfrm>
              <a:off x="2203675" y="1866902"/>
              <a:ext cx="2187248" cy="21031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649" t="7112" b="16651"/>
            <a:stretch/>
          </p:blipFill>
          <p:spPr bwMode="auto">
            <a:xfrm>
              <a:off x="4128377" y="1866900"/>
              <a:ext cx="2187248" cy="21031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6"/>
            <p:cNvPicPr>
              <a:picLocks noChangeAspect="1" noChangeArrowheads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038" t="7111" b="16652"/>
            <a:stretch/>
          </p:blipFill>
          <p:spPr bwMode="auto">
            <a:xfrm>
              <a:off x="6110137" y="1866900"/>
              <a:ext cx="2202222" cy="21031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 noChangeArrowheads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1860" t="7672" b="18197"/>
            <a:stretch/>
          </p:blipFill>
          <p:spPr bwMode="auto">
            <a:xfrm>
              <a:off x="261336" y="1889760"/>
              <a:ext cx="2208835" cy="20573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1"/>
            <p:cNvSpPr txBox="1"/>
            <p:nvPr/>
          </p:nvSpPr>
          <p:spPr>
            <a:xfrm>
              <a:off x="307775" y="3895556"/>
              <a:ext cx="2141220" cy="106308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RP        TCGA    MSKC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n = 36         45            29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 = 0.0063      0.0001      0.000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Box 7"/>
            <p:cNvSpPr txBox="1"/>
            <p:nvPr/>
          </p:nvSpPr>
          <p:spPr>
            <a:xfrm>
              <a:off x="2249710" y="3895556"/>
              <a:ext cx="2141220" cy="95261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  RP        TCGA   MSKC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n = 36         50            28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 = 0.0017      0.0001      0.000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" name="TextBox 8"/>
            <p:cNvSpPr txBox="1"/>
            <p:nvPr/>
          </p:nvSpPr>
          <p:spPr>
            <a:xfrm>
              <a:off x="4174404" y="3895556"/>
              <a:ext cx="2141220" cy="95261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  RP        TCGA   MSKC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n = 36         50            28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 = 0.0002      0.0001      0.000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" name="TextBox 9"/>
            <p:cNvSpPr txBox="1"/>
            <p:nvPr/>
          </p:nvSpPr>
          <p:spPr>
            <a:xfrm>
              <a:off x="6171140" y="3895556"/>
              <a:ext cx="2141222" cy="85442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  RP        TCGA   MSKC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   n = 36         50            28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 = 0.0004      0.0001      0.000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" name="TextBox 2"/>
            <p:cNvSpPr txBox="1"/>
            <p:nvPr/>
          </p:nvSpPr>
          <p:spPr>
            <a:xfrm rot="16200000">
              <a:off x="-1080942" y="2509534"/>
              <a:ext cx="2536292" cy="76624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Log2 Fold Chang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(Tumor / Matched Normal)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" name="TextBox 11"/>
            <p:cNvSpPr txBox="1"/>
            <p:nvPr/>
          </p:nvSpPr>
          <p:spPr>
            <a:xfrm>
              <a:off x="968412" y="1530369"/>
              <a:ext cx="912482" cy="35945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RARG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" name="TextBox 12"/>
            <p:cNvSpPr txBox="1"/>
            <p:nvPr/>
          </p:nvSpPr>
          <p:spPr>
            <a:xfrm>
              <a:off x="2897485" y="1530369"/>
              <a:ext cx="1038220" cy="35952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6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6" name="TextBox 13"/>
            <p:cNvSpPr txBox="1"/>
            <p:nvPr/>
          </p:nvSpPr>
          <p:spPr>
            <a:xfrm>
              <a:off x="4745177" y="1530303"/>
              <a:ext cx="1152446" cy="35952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2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" name="TextBox 14"/>
            <p:cNvSpPr txBox="1"/>
            <p:nvPr/>
          </p:nvSpPr>
          <p:spPr>
            <a:xfrm>
              <a:off x="6792063" y="1530303"/>
              <a:ext cx="1113920" cy="4335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3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-6273" y="3094579"/>
            <a:ext cx="7161110" cy="1964055"/>
            <a:chOff x="122975" y="0"/>
            <a:chExt cx="7161110" cy="1964055"/>
          </a:xfrm>
        </p:grpSpPr>
        <p:grpSp>
          <p:nvGrpSpPr>
            <p:cNvPr id="19" name="Group 18"/>
            <p:cNvGrpSpPr/>
            <p:nvPr/>
          </p:nvGrpSpPr>
          <p:grpSpPr>
            <a:xfrm>
              <a:off x="122975" y="0"/>
              <a:ext cx="6965182" cy="1964055"/>
              <a:chOff x="122975" y="0"/>
              <a:chExt cx="6965182" cy="1964055"/>
            </a:xfrm>
          </p:grpSpPr>
          <p:grpSp>
            <p:nvGrpSpPr>
              <p:cNvPr id="21" name="Group 20"/>
              <p:cNvGrpSpPr/>
              <p:nvPr/>
            </p:nvGrpSpPr>
            <p:grpSpPr>
              <a:xfrm>
                <a:off x="122975" y="0"/>
                <a:ext cx="6965182" cy="1964055"/>
                <a:chOff x="122975" y="0"/>
                <a:chExt cx="6965182" cy="1964055"/>
              </a:xfrm>
            </p:grpSpPr>
            <p:grpSp>
              <p:nvGrpSpPr>
                <p:cNvPr id="23" name="Group 22"/>
                <p:cNvGrpSpPr/>
                <p:nvPr/>
              </p:nvGrpSpPr>
              <p:grpSpPr>
                <a:xfrm>
                  <a:off x="122975" y="0"/>
                  <a:ext cx="6965182" cy="1964055"/>
                  <a:chOff x="122975" y="0"/>
                  <a:chExt cx="6965182" cy="1964055"/>
                </a:xfrm>
              </p:grpSpPr>
              <p:sp>
                <p:nvSpPr>
                  <p:cNvPr id="25" name="TextBox 21"/>
                  <p:cNvSpPr txBox="1"/>
                  <p:nvPr/>
                </p:nvSpPr>
                <p:spPr>
                  <a:xfrm>
                    <a:off x="228600" y="1533525"/>
                    <a:ext cx="2140585" cy="43053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100" b="1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 6            7           &gt; 7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  <a:p>
                    <a:pPr marL="0" marR="0" algn="ctr"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100" b="1" kern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Gleason Sum</a:t>
                    </a:r>
                    <a:endParaRPr lang="en-US" sz="1200"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26" name="Group 25"/>
                  <p:cNvGrpSpPr/>
                  <p:nvPr/>
                </p:nvGrpSpPr>
                <p:grpSpPr>
                  <a:xfrm>
                    <a:off x="122975" y="0"/>
                    <a:ext cx="6965182" cy="1543050"/>
                    <a:chOff x="6165" y="58103"/>
                    <a:chExt cx="6965182" cy="1543050"/>
                  </a:xfrm>
                </p:grpSpPr>
                <p:pic>
                  <p:nvPicPr>
                    <p:cNvPr id="27" name="Picture 26"/>
                    <p:cNvPicPr>
                      <a:picLocks noChangeAspect="1"/>
                    </p:cNvPicPr>
                    <p:nvPr/>
                  </p:nvPicPr>
                  <p:blipFill rotWithShape="1">
                    <a:blip r:embed="rId6" cstate="screen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9739" t="15417" b="13279"/>
                    <a:stretch/>
                  </p:blipFill>
                  <p:spPr bwMode="auto">
                    <a:xfrm>
                      <a:off x="408622" y="96203"/>
                      <a:ext cx="1504950" cy="15049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/>
                  </p:spPr>
                </p:pic>
                <p:pic>
                  <p:nvPicPr>
                    <p:cNvPr id="28" name="Picture 27"/>
                    <p:cNvPicPr>
                      <a:picLocks noChangeAspect="1"/>
                    </p:cNvPicPr>
                    <p:nvPr/>
                  </p:nvPicPr>
                  <p:blipFill rotWithShape="1">
                    <a:blip r:embed="rId7" cstate="screen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8666" t="16561" r="-2000" b="14396"/>
                    <a:stretch/>
                  </p:blipFill>
                  <p:spPr bwMode="auto">
                    <a:xfrm>
                      <a:off x="1961197" y="96203"/>
                      <a:ext cx="1619250" cy="15049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/>
                  </p:spPr>
                </p:pic>
                <p:pic>
                  <p:nvPicPr>
                    <p:cNvPr id="29" name="Picture 28"/>
                    <p:cNvPicPr>
                      <a:picLocks noChangeAspect="1"/>
                    </p:cNvPicPr>
                    <p:nvPr/>
                  </p:nvPicPr>
                  <p:blipFill rotWithShape="1">
                    <a:blip r:embed="rId8" cstate="screen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8347" t="17225" r="-887" b="13730"/>
                    <a:stretch/>
                  </p:blipFill>
                  <p:spPr bwMode="auto">
                    <a:xfrm>
                      <a:off x="3580447" y="86678"/>
                      <a:ext cx="1590675" cy="14954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/>
                  </p:spPr>
                </p:pic>
                <p:pic>
                  <p:nvPicPr>
                    <p:cNvPr id="30" name="Picture 29"/>
                    <p:cNvPicPr>
                      <a:picLocks noChangeAspect="1"/>
                    </p:cNvPicPr>
                    <p:nvPr/>
                  </p:nvPicPr>
                  <p:blipFill rotWithShape="1">
                    <a:blip r:embed="rId9" cstate="screen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 l="8079" t="15194" r="-8079" b="14504"/>
                    <a:stretch/>
                  </p:blipFill>
                  <p:spPr bwMode="auto">
                    <a:xfrm>
                      <a:off x="5161597" y="58103"/>
                      <a:ext cx="1809750" cy="14954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/>
                  </p:spPr>
                </p:pic>
                <p:sp>
                  <p:nvSpPr>
                    <p:cNvPr id="31" name="TextBox 22"/>
                    <p:cNvSpPr txBox="1"/>
                    <p:nvPr/>
                  </p:nvSpPr>
                  <p:spPr>
                    <a:xfrm rot="16200000">
                      <a:off x="-530410" y="675323"/>
                      <a:ext cx="1443355" cy="37020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g2 Fold Change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Tumor / Matched Normal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24" name="TextBox 21"/>
                <p:cNvSpPr txBox="1"/>
                <p:nvPr/>
              </p:nvSpPr>
              <p:spPr>
                <a:xfrm>
                  <a:off x="1866900" y="1514475"/>
                  <a:ext cx="2140585" cy="4305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algn="ctr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 kern="1200">
                      <a:solidFill>
                        <a:srgbClr val="000000"/>
                      </a:solidFill>
                      <a:effectLst/>
                      <a:latin typeface="Calibri" panose="020F0502020204030204" pitchFamily="34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6            7           &gt; 7</a:t>
                  </a:r>
                  <a:endParaRPr lang="en-US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  <a:p>
                  <a:pPr marL="0" marR="0" algn="ctr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100" b="1" kern="1200">
                      <a:solidFill>
                        <a:srgbClr val="000000"/>
                      </a:solidFill>
                      <a:effectLst/>
                      <a:latin typeface="Calibri" panose="020F0502020204030204" pitchFamily="34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eason Sum</a:t>
                  </a:r>
                  <a:endParaRPr lang="en-US" sz="120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" name="TextBox 21"/>
              <p:cNvSpPr txBox="1"/>
              <p:nvPr/>
            </p:nvSpPr>
            <p:spPr>
              <a:xfrm>
                <a:off x="3495675" y="1514475"/>
                <a:ext cx="2140585" cy="4305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algn="ctr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6            7           &gt; 7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 algn="ctr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100" b="1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leason Sum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20" name="TextBox 21"/>
            <p:cNvSpPr txBox="1"/>
            <p:nvPr/>
          </p:nvSpPr>
          <p:spPr>
            <a:xfrm>
              <a:off x="5143500" y="1495425"/>
              <a:ext cx="2140585" cy="430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6            7           &gt; 7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leason Sum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32" name="Rectangle 31"/>
          <p:cNvSpPr/>
          <p:nvPr/>
        </p:nvSpPr>
        <p:spPr>
          <a:xfrm>
            <a:off x="1967539" y="8622904"/>
            <a:ext cx="2839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1 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44996" y="2816841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51269" y="1236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502755" y="5585838"/>
            <a:ext cx="1797717" cy="2549884"/>
            <a:chOff x="4940708" y="661064"/>
            <a:chExt cx="3986413" cy="5781884"/>
          </a:xfrm>
        </p:grpSpPr>
        <p:pic>
          <p:nvPicPr>
            <p:cNvPr id="36" name="Picture 4"/>
            <p:cNvPicPr>
              <a:picLocks noChangeAspect="1" noChangeArrowheads="1"/>
            </p:cNvPicPr>
            <p:nvPr/>
          </p:nvPicPr>
          <p:blipFill rotWithShape="1"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940708" y="1621863"/>
              <a:ext cx="3986413" cy="48210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TextBox 36"/>
            <p:cNvSpPr txBox="1"/>
            <p:nvPr/>
          </p:nvSpPr>
          <p:spPr>
            <a:xfrm>
              <a:off x="5248293" y="661064"/>
              <a:ext cx="3477147" cy="907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TCGA-PRAD:</a:t>
              </a:r>
            </a:p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miR-96 x Gleason Sum</a:t>
              </a: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2198692" y="5574266"/>
            <a:ext cx="1831451" cy="2478655"/>
            <a:chOff x="3307629" y="9303147"/>
            <a:chExt cx="3090812" cy="4497947"/>
          </a:xfrm>
        </p:grpSpPr>
        <p:pic>
          <p:nvPicPr>
            <p:cNvPr id="39" name="Picture 38"/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307629" y="10062952"/>
              <a:ext cx="3090812" cy="3738142"/>
            </a:xfrm>
            <a:prstGeom prst="rect">
              <a:avLst/>
            </a:prstGeom>
            <a:noFill/>
            <a:ln>
              <a:noFill/>
            </a:ln>
            <a:extLst/>
          </p:spPr>
        </p:pic>
        <p:sp>
          <p:nvSpPr>
            <p:cNvPr id="40" name="TextBox 39"/>
            <p:cNvSpPr txBox="1"/>
            <p:nvPr/>
          </p:nvSpPr>
          <p:spPr>
            <a:xfrm>
              <a:off x="3479396" y="9303147"/>
              <a:ext cx="2681471" cy="7260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TCGA-PRAD:</a:t>
              </a:r>
            </a:p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miR-96 x Clinical Stage</a:t>
              </a:r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99352" y="558583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90112" y="5981345"/>
            <a:ext cx="2617839" cy="1937963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4023889" y="563585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652382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028" t="8060" b="7125"/>
          <a:stretch/>
        </p:blipFill>
        <p:spPr bwMode="auto">
          <a:xfrm>
            <a:off x="3459750" y="1438177"/>
            <a:ext cx="1289418" cy="13572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028" t="9310" b="7246"/>
          <a:stretch/>
        </p:blipFill>
        <p:spPr bwMode="auto">
          <a:xfrm>
            <a:off x="1999194" y="1491053"/>
            <a:ext cx="1302673" cy="1304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377236" y="8609163"/>
            <a:ext cx="277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2</a:t>
            </a:r>
          </a:p>
        </p:txBody>
      </p:sp>
      <p:pic>
        <p:nvPicPr>
          <p:cNvPr id="4" name="Picture 3"/>
          <p:cNvPicPr/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5852" t="7560" b="13290"/>
          <a:stretch/>
        </p:blipFill>
        <p:spPr bwMode="auto">
          <a:xfrm>
            <a:off x="3449217" y="3949834"/>
            <a:ext cx="1299951" cy="13956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59"/>
          <p:cNvSpPr txBox="1"/>
          <p:nvPr/>
        </p:nvSpPr>
        <p:spPr>
          <a:xfrm>
            <a:off x="3590222" y="2741288"/>
            <a:ext cx="591778" cy="18282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6" name="TextBox 60"/>
          <p:cNvSpPr txBox="1"/>
          <p:nvPr/>
        </p:nvSpPr>
        <p:spPr>
          <a:xfrm>
            <a:off x="4090679" y="2740479"/>
            <a:ext cx="624441" cy="17458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8" name="TextBox 3"/>
          <p:cNvSpPr txBox="1"/>
          <p:nvPr/>
        </p:nvSpPr>
        <p:spPr>
          <a:xfrm rot="16200000">
            <a:off x="2624360" y="1971003"/>
            <a:ext cx="1422928" cy="11472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Log Fold Change (miR-96)</a:t>
            </a:r>
            <a:endParaRPr lang="en-US" sz="1000" dirty="0">
              <a:latin typeface="Times New Roman"/>
              <a:ea typeface="Times New Roman"/>
            </a:endParaRPr>
          </a:p>
        </p:txBody>
      </p:sp>
      <p:pic>
        <p:nvPicPr>
          <p:cNvPr id="11" name="Picture 10"/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9677" t="8902" b="7765"/>
          <a:stretch/>
        </p:blipFill>
        <p:spPr bwMode="auto">
          <a:xfrm>
            <a:off x="1824474" y="3818286"/>
            <a:ext cx="1522708" cy="15402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2"/>
          <p:cNvSpPr txBox="1"/>
          <p:nvPr/>
        </p:nvSpPr>
        <p:spPr>
          <a:xfrm>
            <a:off x="2110391" y="2748350"/>
            <a:ext cx="551155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13" name="TextBox 57"/>
          <p:cNvSpPr txBox="1"/>
          <p:nvPr/>
        </p:nvSpPr>
        <p:spPr>
          <a:xfrm>
            <a:off x="2666877" y="2750264"/>
            <a:ext cx="482448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14" name="TextBox 69"/>
          <p:cNvSpPr txBox="1"/>
          <p:nvPr/>
        </p:nvSpPr>
        <p:spPr>
          <a:xfrm rot="16200000">
            <a:off x="1161722" y="2016166"/>
            <a:ext cx="1393397" cy="11470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ea typeface="Times New Roman"/>
                <a:cs typeface="Times New Roman"/>
              </a:rPr>
              <a:t>Log Fold Change (miR-96)</a:t>
            </a:r>
            <a:endParaRPr lang="en-US" sz="1000" dirty="0">
              <a:latin typeface="Times New Roman"/>
              <a:ea typeface="Times New Roman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4654852" y="3860929"/>
            <a:ext cx="1433151" cy="564707"/>
            <a:chOff x="239492" y="0"/>
            <a:chExt cx="1535594" cy="604158"/>
          </a:xfrm>
        </p:grpSpPr>
        <p:grpSp>
          <p:nvGrpSpPr>
            <p:cNvPr id="18" name="Group 17"/>
            <p:cNvGrpSpPr/>
            <p:nvPr/>
          </p:nvGrpSpPr>
          <p:grpSpPr>
            <a:xfrm>
              <a:off x="239492" y="0"/>
              <a:ext cx="1535515" cy="604157"/>
              <a:chOff x="65320" y="0"/>
              <a:chExt cx="1535515" cy="604157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185063" y="0"/>
                <a:ext cx="1415772" cy="604157"/>
                <a:chOff x="65320" y="0"/>
                <a:chExt cx="1415772" cy="604157"/>
              </a:xfrm>
            </p:grpSpPr>
            <p:grpSp>
              <p:nvGrpSpPr>
                <p:cNvPr id="22" name="Group 21"/>
                <p:cNvGrpSpPr/>
                <p:nvPr/>
              </p:nvGrpSpPr>
              <p:grpSpPr>
                <a:xfrm>
                  <a:off x="489857" y="0"/>
                  <a:ext cx="991235" cy="604157"/>
                  <a:chOff x="0" y="0"/>
                  <a:chExt cx="991235" cy="604157"/>
                </a:xfrm>
              </p:grpSpPr>
              <p:pic>
                <p:nvPicPr>
                  <p:cNvPr id="24" name="Picture 23" descr="W:\Chemi-Doc\LNCaP_NC_miR96_siRARG_112114\Long, Mark 2014-11-21 15hr 22min_Exposure_810.jpg"/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 bwMode="auto">
                  <a:xfrm rot="10800000">
                    <a:off x="0" y="337457"/>
                    <a:ext cx="991235" cy="26670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25" name="Picture 24" descr="W:\Chemi-Doc\LNCaP_NC_miR96_siRARG_112114\Long, Mark 2014-11-21 15hr 22min_Exposure_810.jpg"/>
                  <p:cNvPicPr>
                    <a:picLocks noChangeAspect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 bwMode="auto">
                  <a:xfrm rot="10800000">
                    <a:off x="0" y="0"/>
                    <a:ext cx="990600" cy="30480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23" name="TextBox 38"/>
                <p:cNvSpPr txBox="1"/>
                <p:nvPr/>
              </p:nvSpPr>
              <p:spPr>
                <a:xfrm>
                  <a:off x="65320" y="21772"/>
                  <a:ext cx="446919" cy="234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b="1" dirty="0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RAR</a:t>
                  </a:r>
                  <a:r>
                    <a:rPr lang="el-GR" sz="825" b="1" dirty="0">
                      <a:solidFill>
                        <a:srgbClr val="000000"/>
                      </a:solidFill>
                      <a:latin typeface="Calibri"/>
                      <a:ea typeface="Times New Roman"/>
                      <a:cs typeface="Times New Roman"/>
                    </a:rPr>
                    <a:t>γ</a:t>
                  </a:r>
                  <a:endParaRPr lang="en-US" sz="900" b="1" dirty="0">
                    <a:latin typeface="Times New Roman"/>
                    <a:ea typeface="Times New Roman"/>
                  </a:endParaRPr>
                </a:p>
              </p:txBody>
            </p:sp>
          </p:grpSp>
          <p:sp>
            <p:nvSpPr>
              <p:cNvPr id="21" name="TextBox 39"/>
              <p:cNvSpPr txBox="1"/>
              <p:nvPr/>
            </p:nvSpPr>
            <p:spPr>
              <a:xfrm>
                <a:off x="65320" y="326423"/>
                <a:ext cx="543103" cy="2346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b="1" dirty="0">
                    <a:solidFill>
                      <a:srgbClr val="000000"/>
                    </a:solidFill>
                    <a:latin typeface="Calibri"/>
                    <a:ea typeface="Times New Roman"/>
                    <a:cs typeface="Times New Roman"/>
                  </a:rPr>
                  <a:t>GAPDH</a:t>
                </a:r>
                <a:endParaRPr lang="en-US" sz="900" b="1" dirty="0">
                  <a:latin typeface="Times New Roman"/>
                  <a:ea typeface="Times New Roman"/>
                </a:endParaRPr>
              </a:p>
            </p:txBody>
          </p:sp>
        </p:grpSp>
        <p:sp>
          <p:nvSpPr>
            <p:cNvPr id="17" name="Rectangle 16"/>
            <p:cNvSpPr/>
            <p:nvPr/>
          </p:nvSpPr>
          <p:spPr>
            <a:xfrm>
              <a:off x="772886" y="0"/>
              <a:ext cx="1002200" cy="6041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 sz="1350"/>
            </a:p>
          </p:txBody>
        </p:sp>
      </p:grpSp>
      <p:sp>
        <p:nvSpPr>
          <p:cNvPr id="28" name="TextBox 71"/>
          <p:cNvSpPr txBox="1"/>
          <p:nvPr/>
        </p:nvSpPr>
        <p:spPr>
          <a:xfrm>
            <a:off x="2135163" y="3614851"/>
            <a:ext cx="1145173" cy="21418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000" b="1" i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RARG</a:t>
            </a:r>
            <a:r>
              <a:rPr lang="en-US" sz="10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 Expression</a:t>
            </a:r>
            <a:endParaRPr lang="en-US" sz="1000" dirty="0">
              <a:latin typeface="Times New Roman"/>
              <a:ea typeface="Times New Roman"/>
            </a:endParaRPr>
          </a:p>
        </p:txBody>
      </p:sp>
      <p:sp>
        <p:nvSpPr>
          <p:cNvPr id="30" name="TextBox 71"/>
          <p:cNvSpPr txBox="1"/>
          <p:nvPr/>
        </p:nvSpPr>
        <p:spPr>
          <a:xfrm>
            <a:off x="3628642" y="3614851"/>
            <a:ext cx="1145173" cy="21418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RAR</a:t>
            </a:r>
            <a:r>
              <a:rPr lang="el-GR" sz="10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γ</a:t>
            </a:r>
            <a:r>
              <a:rPr lang="en-US" sz="10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 Expression</a:t>
            </a:r>
            <a:endParaRPr lang="en-US" sz="1000" dirty="0">
              <a:latin typeface="Times New Roman"/>
              <a:ea typeface="Times New Roman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706392" y="114747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139388" y="114400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678630" y="3537920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36" name="TextBox 2"/>
          <p:cNvSpPr txBox="1"/>
          <p:nvPr/>
        </p:nvSpPr>
        <p:spPr>
          <a:xfrm>
            <a:off x="1881826" y="5313491"/>
            <a:ext cx="551155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37" name="TextBox 57"/>
          <p:cNvSpPr txBox="1"/>
          <p:nvPr/>
        </p:nvSpPr>
        <p:spPr>
          <a:xfrm>
            <a:off x="2301132" y="5313491"/>
            <a:ext cx="482448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38" name="TextBox 57"/>
          <p:cNvSpPr txBox="1"/>
          <p:nvPr/>
        </p:nvSpPr>
        <p:spPr>
          <a:xfrm>
            <a:off x="2718678" y="5319129"/>
            <a:ext cx="685856" cy="16172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siRARG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39" name="TextBox 2"/>
          <p:cNvSpPr txBox="1"/>
          <p:nvPr/>
        </p:nvSpPr>
        <p:spPr>
          <a:xfrm>
            <a:off x="3464598" y="5301131"/>
            <a:ext cx="551155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40" name="TextBox 57"/>
          <p:cNvSpPr txBox="1"/>
          <p:nvPr/>
        </p:nvSpPr>
        <p:spPr>
          <a:xfrm>
            <a:off x="3883904" y="5301131"/>
            <a:ext cx="482448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41" name="TextBox 57"/>
          <p:cNvSpPr txBox="1"/>
          <p:nvPr/>
        </p:nvSpPr>
        <p:spPr>
          <a:xfrm>
            <a:off x="4301450" y="5306769"/>
            <a:ext cx="685856" cy="16172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siRARG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42" name="TextBox 69"/>
          <p:cNvSpPr txBox="1"/>
          <p:nvPr/>
        </p:nvSpPr>
        <p:spPr>
          <a:xfrm rot="16200000">
            <a:off x="1080442" y="4470793"/>
            <a:ext cx="1156623" cy="11470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900" b="1" dirty="0">
                <a:solidFill>
                  <a:srgbClr val="000000"/>
                </a:solidFill>
                <a:ea typeface="Times New Roman"/>
                <a:cs typeface="Times New Roman"/>
              </a:rPr>
              <a:t>Fold Change </a:t>
            </a:r>
            <a:endParaRPr lang="en-US" sz="1050" dirty="0">
              <a:latin typeface="Times New Roman"/>
              <a:ea typeface="Times New Roman"/>
            </a:endParaRPr>
          </a:p>
        </p:txBody>
      </p:sp>
      <p:sp>
        <p:nvSpPr>
          <p:cNvPr id="43" name="TextBox 69"/>
          <p:cNvSpPr txBox="1"/>
          <p:nvPr/>
        </p:nvSpPr>
        <p:spPr>
          <a:xfrm rot="16200000">
            <a:off x="2756873" y="4470794"/>
            <a:ext cx="1156623" cy="11470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900" b="1" dirty="0">
                <a:solidFill>
                  <a:srgbClr val="000000"/>
                </a:solidFill>
                <a:ea typeface="Times New Roman"/>
                <a:cs typeface="Times New Roman"/>
              </a:rPr>
              <a:t>Fold Change </a:t>
            </a:r>
            <a:endParaRPr lang="en-US" sz="1050" dirty="0">
              <a:latin typeface="Times New Roman"/>
              <a:ea typeface="Times New Roman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328967" y="1261478"/>
            <a:ext cx="6431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RWPE-1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865930" y="1233689"/>
            <a:ext cx="5325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/>
              <a:t>LNCaP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1415220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86119" y="386172"/>
            <a:ext cx="5990590" cy="3404870"/>
          </a:xfrm>
          <a:prstGeom prst="rect">
            <a:avLst/>
          </a:prstGeom>
          <a:noFill/>
          <a:ln>
            <a:noFill/>
          </a:ln>
          <a:effectLst/>
          <a:extLst/>
        </p:spPr>
      </p:pic>
      <p:sp>
        <p:nvSpPr>
          <p:cNvPr id="7" name="Rectangle 6"/>
          <p:cNvSpPr/>
          <p:nvPr/>
        </p:nvSpPr>
        <p:spPr>
          <a:xfrm>
            <a:off x="1967539" y="8762887"/>
            <a:ext cx="27751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EEEF773-CADB-B849-805D-E3A66878E34A}"/>
              </a:ext>
            </a:extLst>
          </p:cNvPr>
          <p:cNvSpPr txBox="1"/>
          <p:nvPr/>
        </p:nvSpPr>
        <p:spPr>
          <a:xfrm>
            <a:off x="286119" y="47583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90A608-696C-0F4A-9F78-DC9C936882BF}"/>
              </a:ext>
            </a:extLst>
          </p:cNvPr>
          <p:cNvSpPr txBox="1"/>
          <p:nvPr/>
        </p:nvSpPr>
        <p:spPr>
          <a:xfrm>
            <a:off x="286119" y="4578500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A5CFDEE-2D0D-D442-9484-3DF6F9A936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2216" y="4264014"/>
            <a:ext cx="4521200" cy="40259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34790" y="9448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*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1012" y="968097"/>
            <a:ext cx="652743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 err="1"/>
              <a:t>miR</a:t>
            </a:r>
            <a:r>
              <a:rPr lang="en-US" sz="1100" dirty="0"/>
              <a:t>-CTL</a:t>
            </a:r>
          </a:p>
          <a:p>
            <a:r>
              <a:rPr lang="en-US" sz="1100" dirty="0"/>
              <a:t>miR-9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97112" y="957381"/>
            <a:ext cx="652743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 err="1"/>
              <a:t>miR</a:t>
            </a:r>
            <a:r>
              <a:rPr lang="en-US" sz="1100" dirty="0"/>
              <a:t>-CTL</a:t>
            </a:r>
          </a:p>
          <a:p>
            <a:r>
              <a:rPr lang="en-US" sz="1100" dirty="0"/>
              <a:t>miR-96</a:t>
            </a:r>
          </a:p>
        </p:txBody>
      </p:sp>
    </p:spTree>
    <p:extLst>
      <p:ext uri="{BB962C8B-B14F-4D97-AF65-F5344CB8AC3E}">
        <p14:creationId xmlns:p14="http://schemas.microsoft.com/office/powerpoint/2010/main" val="19136516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2534"/>
          <a:stretch/>
        </p:blipFill>
        <p:spPr bwMode="auto">
          <a:xfrm>
            <a:off x="238222" y="95769"/>
            <a:ext cx="1762760" cy="17406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2219495" y="505033"/>
            <a:ext cx="1410609" cy="1134745"/>
            <a:chOff x="2724907" y="1355725"/>
            <a:chExt cx="1410609" cy="1134745"/>
          </a:xfrm>
        </p:grpSpPr>
        <p:pic>
          <p:nvPicPr>
            <p:cNvPr id="4" name="Picture 3" descr="W:\Chemi-Doc\LNCaP_bimiR96_RARG_012915\LNCaP_bimiR96_48hr_GAPDH_012915.jpg"/>
            <p:cNvPicPr/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468766" y="1698625"/>
              <a:ext cx="609600" cy="3111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W:\Chemi-Doc\LNCaP_bimiR96_RARG_012915\870 sec_final.jpg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468766" y="1371600"/>
              <a:ext cx="609600" cy="2698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2"/>
            <p:cNvSpPr txBox="1"/>
            <p:nvPr/>
          </p:nvSpPr>
          <p:spPr>
            <a:xfrm>
              <a:off x="2865516" y="1355725"/>
              <a:ext cx="546735" cy="32258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RAR</a:t>
              </a:r>
              <a:r>
                <a:rPr lang="el-GR" sz="12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γ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" name="TextBox 18"/>
            <p:cNvSpPr txBox="1"/>
            <p:nvPr/>
          </p:nvSpPr>
          <p:spPr>
            <a:xfrm>
              <a:off x="3452256" y="1962785"/>
              <a:ext cx="683260" cy="52768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+        -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-        +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" name="TextBox 19"/>
            <p:cNvSpPr txBox="1"/>
            <p:nvPr/>
          </p:nvSpPr>
          <p:spPr>
            <a:xfrm>
              <a:off x="2729650" y="1698625"/>
              <a:ext cx="689610" cy="3124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" name="TextBox 12"/>
            <p:cNvSpPr txBox="1"/>
            <p:nvPr/>
          </p:nvSpPr>
          <p:spPr>
            <a:xfrm>
              <a:off x="2724907" y="1995382"/>
              <a:ext cx="712470" cy="2489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i-</a:t>
              </a:r>
              <a:r>
                <a:rPr lang="en-US" sz="900" b="1" kern="1200" dirty="0" err="1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</a:t>
              </a:r>
              <a:r>
                <a:rPr lang="en-US" sz="9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-CTL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Box 21"/>
            <p:cNvSpPr txBox="1"/>
            <p:nvPr/>
          </p:nvSpPr>
          <p:spPr>
            <a:xfrm>
              <a:off x="2736337" y="2166505"/>
              <a:ext cx="689610" cy="2489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i-miR-96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3083832" y="6551369"/>
            <a:ext cx="2874677" cy="2149806"/>
            <a:chOff x="1547384" y="2977751"/>
            <a:chExt cx="3482630" cy="2901147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47384" y="2977751"/>
              <a:ext cx="3303301" cy="2901146"/>
            </a:xfrm>
            <a:prstGeom prst="rect">
              <a:avLst/>
            </a:prstGeom>
          </p:spPr>
        </p:pic>
        <p:sp>
          <p:nvSpPr>
            <p:cNvPr id="21" name="Rectangle 20"/>
            <p:cNvSpPr/>
            <p:nvPr/>
          </p:nvSpPr>
          <p:spPr>
            <a:xfrm>
              <a:off x="4671356" y="5510598"/>
              <a:ext cx="358658" cy="368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-26072" y="9576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019681" y="7029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19779" y="4767503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sp>
        <p:nvSpPr>
          <p:cNvPr id="30" name="Rectangle 29"/>
          <p:cNvSpPr/>
          <p:nvPr/>
        </p:nvSpPr>
        <p:spPr>
          <a:xfrm>
            <a:off x="2000982" y="8760710"/>
            <a:ext cx="2839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4 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28778" y="231832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176888" y="271361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388433" y="2384309"/>
            <a:ext cx="3729508" cy="2012058"/>
            <a:chOff x="0" y="0"/>
            <a:chExt cx="5791200" cy="2686473"/>
          </a:xfrm>
        </p:grpSpPr>
        <p:pic>
          <p:nvPicPr>
            <p:cNvPr id="27" name="Picture 26"/>
            <p:cNvPicPr>
              <a:picLocks noChangeAspect="1" noChangeArrowheads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5791200" cy="268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Oval 27"/>
            <p:cNvSpPr/>
            <p:nvPr/>
          </p:nvSpPr>
          <p:spPr>
            <a:xfrm>
              <a:off x="566837" y="1954303"/>
              <a:ext cx="76200" cy="762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29" name="Oval 28"/>
            <p:cNvSpPr/>
            <p:nvPr/>
          </p:nvSpPr>
          <p:spPr>
            <a:xfrm>
              <a:off x="1023131" y="2106703"/>
              <a:ext cx="76200" cy="762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31" name="Oval 30"/>
            <p:cNvSpPr/>
            <p:nvPr/>
          </p:nvSpPr>
          <p:spPr>
            <a:xfrm>
              <a:off x="1442231" y="2106703"/>
              <a:ext cx="76200" cy="76200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32" name="Oval 31"/>
            <p:cNvSpPr/>
            <p:nvPr/>
          </p:nvSpPr>
          <p:spPr>
            <a:xfrm>
              <a:off x="1900337" y="2160157"/>
              <a:ext cx="76200" cy="762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33" name="Oval 32"/>
            <p:cNvSpPr/>
            <p:nvPr/>
          </p:nvSpPr>
          <p:spPr>
            <a:xfrm>
              <a:off x="2356631" y="2259103"/>
              <a:ext cx="76200" cy="762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34" name="Oval 33"/>
            <p:cNvSpPr/>
            <p:nvPr/>
          </p:nvSpPr>
          <p:spPr>
            <a:xfrm>
              <a:off x="2775731" y="2259103"/>
              <a:ext cx="76200" cy="76200"/>
            </a:xfrm>
            <a:prstGeom prst="ellips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39" name="Oval 38"/>
            <p:cNvSpPr/>
            <p:nvPr/>
          </p:nvSpPr>
          <p:spPr>
            <a:xfrm>
              <a:off x="4491137" y="1725703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0" name="Oval 39"/>
            <p:cNvSpPr/>
            <p:nvPr/>
          </p:nvSpPr>
          <p:spPr>
            <a:xfrm>
              <a:off x="4947431" y="2030503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1" name="Oval 40"/>
            <p:cNvSpPr/>
            <p:nvPr/>
          </p:nvSpPr>
          <p:spPr>
            <a:xfrm>
              <a:off x="5366531" y="2030503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2" name="Oval 41"/>
            <p:cNvSpPr/>
            <p:nvPr/>
          </p:nvSpPr>
          <p:spPr>
            <a:xfrm>
              <a:off x="3233837" y="2153902"/>
              <a:ext cx="76200" cy="76200"/>
            </a:xfrm>
            <a:prstGeom prst="ellipse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3" name="Oval 42"/>
            <p:cNvSpPr/>
            <p:nvPr/>
          </p:nvSpPr>
          <p:spPr>
            <a:xfrm>
              <a:off x="3690131" y="2259103"/>
              <a:ext cx="76200" cy="76200"/>
            </a:xfrm>
            <a:prstGeom prst="ellipse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  <p:sp>
          <p:nvSpPr>
            <p:cNvPr id="44" name="Oval 43"/>
            <p:cNvSpPr/>
            <p:nvPr/>
          </p:nvSpPr>
          <p:spPr>
            <a:xfrm>
              <a:off x="4109231" y="2259103"/>
              <a:ext cx="76200" cy="76200"/>
            </a:xfrm>
            <a:prstGeom prst="ellipse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3737035" y="7029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46" name="Picture 6"/>
          <p:cNvPicPr>
            <a:picLocks noChangeAspect="1" noChangeArrowheads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3765"/>
          <a:stretch/>
        </p:blipFill>
        <p:spPr bwMode="auto">
          <a:xfrm>
            <a:off x="4309729" y="95768"/>
            <a:ext cx="2163857" cy="2755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4" name="Group 13"/>
          <p:cNvGrpSpPr/>
          <p:nvPr/>
        </p:nvGrpSpPr>
        <p:grpSpPr>
          <a:xfrm>
            <a:off x="4496446" y="2850880"/>
            <a:ext cx="1994403" cy="1629930"/>
            <a:chOff x="4023210" y="3294544"/>
            <a:chExt cx="2724831" cy="2368105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9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23210" y="3294544"/>
              <a:ext cx="2724831" cy="2368105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1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150249" y="5079925"/>
              <a:ext cx="517257" cy="243415"/>
            </a:xfrm>
            <a:prstGeom prst="rect">
              <a:avLst/>
            </a:prstGeom>
          </p:spPr>
        </p:pic>
      </p:grpSp>
      <p:pic>
        <p:nvPicPr>
          <p:cNvPr id="48" name="Picture 3" descr="\\CancerGenetics\CG$\SmiragliaLab\Mark Long\Projects\RARg and miR-96-182-183\manuscript\Figs\LNCaP_bimiR96_PCRValidation_2.jpg"/>
          <p:cNvPicPr>
            <a:picLocks noChangeAspect="1" noChangeArrowheads="1"/>
          </p:cNvPicPr>
          <p:nvPr/>
        </p:nvPicPr>
        <p:blipFill rotWithShape="1"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102376" y="4464434"/>
            <a:ext cx="4372195" cy="20566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14097"/>
          <p:cNvPicPr>
            <a:picLocks noChangeAspect="1" noChangeArrowheads="1"/>
          </p:cNvPicPr>
          <p:nvPr/>
        </p:nvPicPr>
        <p:blipFill rotWithShape="1"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570" b="8669"/>
          <a:stretch/>
        </p:blipFill>
        <p:spPr bwMode="auto">
          <a:xfrm>
            <a:off x="1187276" y="6659880"/>
            <a:ext cx="1268697" cy="179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TextBox 52"/>
          <p:cNvSpPr txBox="1"/>
          <p:nvPr/>
        </p:nvSpPr>
        <p:spPr>
          <a:xfrm>
            <a:off x="821818" y="6785645"/>
            <a:ext cx="31931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674535" y="678564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sp>
        <p:nvSpPr>
          <p:cNvPr id="50" name="TextBox 2"/>
          <p:cNvSpPr txBox="1"/>
          <p:nvPr/>
        </p:nvSpPr>
        <p:spPr>
          <a:xfrm>
            <a:off x="1474579" y="8395907"/>
            <a:ext cx="551155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51" name="TextBox 57"/>
          <p:cNvSpPr txBox="1"/>
          <p:nvPr/>
        </p:nvSpPr>
        <p:spPr>
          <a:xfrm>
            <a:off x="1947421" y="8395907"/>
            <a:ext cx="482448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52" name="TextBox 2"/>
          <p:cNvSpPr txBox="1"/>
          <p:nvPr/>
        </p:nvSpPr>
        <p:spPr>
          <a:xfrm>
            <a:off x="1624837" y="6502603"/>
            <a:ext cx="551155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6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6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600" dirty="0">
              <a:latin typeface="Times New Roman"/>
              <a:ea typeface="Times New Roman"/>
            </a:endParaRPr>
          </a:p>
        </p:txBody>
      </p:sp>
      <p:sp>
        <p:nvSpPr>
          <p:cNvPr id="54" name="TextBox 57"/>
          <p:cNvSpPr txBox="1"/>
          <p:nvPr/>
        </p:nvSpPr>
        <p:spPr>
          <a:xfrm>
            <a:off x="1947421" y="6500689"/>
            <a:ext cx="482448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6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-96</a:t>
            </a:r>
            <a:endParaRPr lang="en-US" sz="600" dirty="0">
              <a:latin typeface="Times New Roman"/>
              <a:ea typeface="Times New Roman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50564" y="6591480"/>
            <a:ext cx="701396" cy="528059"/>
          </a:xfrm>
          <a:prstGeom prst="rect">
            <a:avLst/>
          </a:prstGeom>
        </p:spPr>
      </p:pic>
      <p:sp>
        <p:nvSpPr>
          <p:cNvPr id="55" name="TextBox 2"/>
          <p:cNvSpPr txBox="1"/>
          <p:nvPr/>
        </p:nvSpPr>
        <p:spPr>
          <a:xfrm>
            <a:off x="574375" y="1814523"/>
            <a:ext cx="703543" cy="1757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bi-</a:t>
            </a:r>
            <a:r>
              <a:rPr lang="en-US" sz="800" b="1" dirty="0" err="1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miR</a:t>
            </a:r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-CTL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56" name="TextBox 57"/>
          <p:cNvSpPr txBox="1"/>
          <p:nvPr/>
        </p:nvSpPr>
        <p:spPr>
          <a:xfrm>
            <a:off x="1226897" y="1821817"/>
            <a:ext cx="697470" cy="17384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bi-miR-96</a:t>
            </a:r>
            <a:endParaRPr lang="en-US" sz="800" dirty="0">
              <a:latin typeface="Times New Roman"/>
              <a:ea typeface="Times New Roman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612242" y="4708871"/>
            <a:ext cx="48282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 err="1"/>
              <a:t>miR</a:t>
            </a:r>
            <a:r>
              <a:rPr lang="en-US" sz="700" dirty="0"/>
              <a:t>-CTL</a:t>
            </a:r>
          </a:p>
          <a:p>
            <a:r>
              <a:rPr lang="en-US" sz="700" dirty="0"/>
              <a:t>miR-96</a:t>
            </a:r>
          </a:p>
        </p:txBody>
      </p:sp>
    </p:spTree>
    <p:extLst>
      <p:ext uri="{BB962C8B-B14F-4D97-AF65-F5344CB8AC3E}">
        <p14:creationId xmlns:p14="http://schemas.microsoft.com/office/powerpoint/2010/main" val="29893184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51080" y="6584578"/>
            <a:ext cx="2295712" cy="198753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77209" y="6473096"/>
            <a:ext cx="2339464" cy="206976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41380" y="325139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41380" y="6137819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53644" y="6211486"/>
            <a:ext cx="16594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LNCaP</a:t>
            </a:r>
            <a:r>
              <a:rPr lang="en-US" sz="1100" b="1" dirty="0"/>
              <a:t>: Cell-Cycle Target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48259" y="6184915"/>
            <a:ext cx="22669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LNCaP</a:t>
            </a:r>
            <a:r>
              <a:rPr lang="en-US" sz="1100" b="1" dirty="0"/>
              <a:t>: Transcription Factor Targets</a:t>
            </a:r>
          </a:p>
        </p:txBody>
      </p:sp>
      <p:pic>
        <p:nvPicPr>
          <p:cNvPr id="9" name="Picture 8"/>
          <p:cNvPicPr/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011978" y="21893"/>
            <a:ext cx="4877204" cy="3379543"/>
          </a:xfrm>
          <a:prstGeom prst="rect">
            <a:avLst/>
          </a:prstGeom>
          <a:noFill/>
          <a:ln>
            <a:noFill/>
          </a:ln>
          <a:extLst/>
        </p:spPr>
      </p:pic>
      <p:sp>
        <p:nvSpPr>
          <p:cNvPr id="10" name="TextBox 9"/>
          <p:cNvSpPr txBox="1"/>
          <p:nvPr/>
        </p:nvSpPr>
        <p:spPr>
          <a:xfrm>
            <a:off x="984317" y="110248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967539" y="8762887"/>
            <a:ext cx="28221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5 </a:t>
            </a:r>
          </a:p>
        </p:txBody>
      </p:sp>
      <p:pic>
        <p:nvPicPr>
          <p:cNvPr id="13" name="Picture 12"/>
          <p:cNvPicPr/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10658" y="3416228"/>
            <a:ext cx="5135880" cy="2474595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3465285" y="6123459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4454704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6792915-8F7C-1441-9C42-50F7669777E5}"/>
              </a:ext>
            </a:extLst>
          </p:cNvPr>
          <p:cNvSpPr/>
          <p:nvPr/>
        </p:nvSpPr>
        <p:spPr>
          <a:xfrm>
            <a:off x="1967539" y="8762887"/>
            <a:ext cx="2839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6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75AAF5B-321D-0946-BBE1-3907A135CD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333" r="2519"/>
          <a:stretch/>
        </p:blipFill>
        <p:spPr>
          <a:xfrm>
            <a:off x="182879" y="1075826"/>
            <a:ext cx="6405225" cy="30276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A20327D-2690-804F-BDC8-A8591B00EE35}"/>
              </a:ext>
            </a:extLst>
          </p:cNvPr>
          <p:cNvSpPr txBox="1"/>
          <p:nvPr/>
        </p:nvSpPr>
        <p:spPr>
          <a:xfrm>
            <a:off x="336954" y="795883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59970D3-3B11-2F46-AB10-707F0B936532}"/>
              </a:ext>
            </a:extLst>
          </p:cNvPr>
          <p:cNvSpPr txBox="1"/>
          <p:nvPr/>
        </p:nvSpPr>
        <p:spPr>
          <a:xfrm>
            <a:off x="272218" y="425354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1D62533-BF25-0B46-9A37-7A075DCAFB7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530" t="11225" r="20392" b="13135"/>
          <a:stretch/>
        </p:blipFill>
        <p:spPr>
          <a:xfrm>
            <a:off x="336954" y="4640733"/>
            <a:ext cx="3143897" cy="37741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F2648EC-BE9B-B94A-961C-A8F38CECE44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845" t="9019" r="20730" b="13136"/>
          <a:stretch/>
        </p:blipFill>
        <p:spPr>
          <a:xfrm>
            <a:off x="3480851" y="4640733"/>
            <a:ext cx="3107254" cy="3884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9853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967539" y="8762887"/>
            <a:ext cx="28392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17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A852000-8EF8-1D48-800A-BD88CB7FFD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8000"/>
            <a:ext cx="6858000" cy="3918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49924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3182330"/>
              </p:ext>
            </p:extLst>
          </p:nvPr>
        </p:nvGraphicFramePr>
        <p:xfrm>
          <a:off x="335279" y="177513"/>
          <a:ext cx="6289041" cy="621823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877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506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506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umber of events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47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Vehicle-</a:t>
                      </a:r>
                      <a:r>
                        <a:rPr lang="en-US" sz="1200" dirty="0" err="1">
                          <a:effectLst/>
                        </a:rPr>
                        <a:t>RARg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D437-RARg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642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A) RARg  DEG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717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731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28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B) RARg  cistrome peaks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256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60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599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C) RARg  peaks annotated to genes 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12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55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3556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D)  Annotated  RARg  cistrome genes expressed in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WPE-1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59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0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135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E) Overlap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 &amp; D 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8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8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95853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F) RARg  DEG genes detected in TCGA-PRAD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663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01</a:t>
                      </a:r>
                      <a:endParaRPr lang="en-US" sz="120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2447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G) Top 10 significant GSEA for (F)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UJANA_BRCA1_PCC_NETWORK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ILON_KLF1_TARGETS_DN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UJANA_ATM_PCC_NETWORK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UJANA_CHEK2_PCC_NETWORK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ODD_NASOPHARYNGEAL_CARCINOMA_DN 1375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JOHNSTONE_PARVB_TARGETS_3_DN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RIGE_RESPONSE_TO_TOSEDOSTAT_24HR_DN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UYTTEN_EZH2_TARGETS_DN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UJANA_BRCA2_PCC_NETWORK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ARSON_BOUND_BY_E2F4_UNSTIMULATED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</a:txBody>
                  <a:tcPr marL="4142" marR="4142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RAESSMANN_APOPTOSIS_BY_DOXORUBICIN_UP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ELYS_THYROID_CANCER_UP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RAESSMANN_RESPONSE_TO_MC_AND_DOXORUBICIN_UP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OINUMA_TARGETS_OF_SMAD2_OR_SMAD3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ILD_HRAS_ONCOGENIC_SIGNATURE 261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ELACROIX_RARG_BOUND_MEF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RUINS_UVC_RESPONSE_VIA_TP53_GROUP_B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HETH_LIVER_CANCER_VS_TXNIP_LOSS_PAM1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CGCCTT_MIR525_MIR524</a:t>
                      </a:r>
                    </a:p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ONDER_CDH1_TARGETS_2_DN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Calibri" charset="0"/>
                      </a:endParaRPr>
                    </a:p>
                    <a:p>
                      <a:endParaRPr lang="en-US" sz="1200" dirty="0"/>
                    </a:p>
                  </a:txBody>
                  <a:tcPr marL="4142" marR="4142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18438" y="6727523"/>
            <a:ext cx="6522721" cy="1673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000" b="1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Supplementary Table 1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: Summary of overlaps of the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cistrome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and transcriptomes either treated with vehicle or CD437. (A). Differentially expressed genes (log fold change 1.2, 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p.adj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=0.1) in RWPE1 cells following shRNA to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or treatment with CD437 and detected by microarray analyses (B). Significant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bound 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peaks (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p.adj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&lt; 0.1) in RWPE-1. (C).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bound genes were annotated to +/- 7.5 kb TSS of known genes. (D) Unique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bound genes that are detected by  in RWPE-1 microarray expression set. (E) Overlap of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regulated genes and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bound genes. These sets were used for bootstrap analyses to test significance of relationship between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 binding and gene expression. (F) Number of </a:t>
            </a:r>
            <a:r>
              <a:rPr lang="en-US" sz="1000" dirty="0" err="1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RAR</a:t>
            </a:r>
            <a:r>
              <a:rPr lang="en-US" sz="1000" dirty="0" err="1">
                <a:solidFill>
                  <a:srgbClr val="000000"/>
                </a:solidFill>
                <a:latin typeface="Symbol" charset="2"/>
                <a:ea typeface="Calibri" charset="0"/>
                <a:cs typeface="Arial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latin typeface="Arial" charset="0"/>
                <a:ea typeface="Calibri" charset="0"/>
                <a:cs typeface="Calibri" charset="0"/>
              </a:rPr>
              <a:t>-dependent DEGs expressed in more than 80% tumors compared to normal samples in the TCGA-PRAD. (G) Top 10 significant GSEA terms for (F).</a:t>
            </a:r>
            <a:endParaRPr lang="en-US" sz="1000" dirty="0">
              <a:solidFill>
                <a:srgbClr val="000000"/>
              </a:solidFill>
              <a:effectLst/>
              <a:latin typeface="Calibri" charset="0"/>
              <a:ea typeface="Calibri" charset="0"/>
              <a:cs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278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91676" y="5264071"/>
            <a:ext cx="2166907" cy="346589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18084"/>
          <a:stretch/>
        </p:blipFill>
        <p:spPr>
          <a:xfrm>
            <a:off x="371012" y="3142561"/>
            <a:ext cx="2112264" cy="176382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17825"/>
          <a:stretch/>
        </p:blipFill>
        <p:spPr>
          <a:xfrm>
            <a:off x="2517766" y="3147007"/>
            <a:ext cx="2112264" cy="17582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573901" y="299529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062919" y="872996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</a:t>
            </a:r>
            <a:r>
              <a:rPr lang="en-US">
                <a:latin typeface="Arial" charset="0"/>
                <a:ea typeface="Arial" charset="0"/>
                <a:cs typeface="Arial" charset="0"/>
              </a:rPr>
              <a:t>Figure 2</a:t>
            </a:r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10134" y="642671"/>
            <a:ext cx="2751399" cy="2263437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73386" y="642671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73385" y="2987317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1011" y="665502"/>
            <a:ext cx="2853451" cy="2240689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3464400" y="642670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3177" y="5108693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5265497" y="5480994"/>
            <a:ext cx="1513052" cy="3189836"/>
            <a:chOff x="8700065" y="5094224"/>
            <a:chExt cx="1513052" cy="3189836"/>
          </a:xfrm>
        </p:grpSpPr>
        <p:grpSp>
          <p:nvGrpSpPr>
            <p:cNvPr id="20" name="Group 19"/>
            <p:cNvGrpSpPr/>
            <p:nvPr/>
          </p:nvGrpSpPr>
          <p:grpSpPr>
            <a:xfrm>
              <a:off x="8700065" y="5094224"/>
              <a:ext cx="1513052" cy="3189836"/>
              <a:chOff x="2037222" y="7494685"/>
              <a:chExt cx="1513052" cy="3189836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2037222" y="7494685"/>
                <a:ext cx="1513052" cy="3189836"/>
                <a:chOff x="-1075017" y="3961352"/>
                <a:chExt cx="1723302" cy="3711335"/>
              </a:xfrm>
            </p:grpSpPr>
            <p:grpSp>
              <p:nvGrpSpPr>
                <p:cNvPr id="25" name="Group 24"/>
                <p:cNvGrpSpPr/>
                <p:nvPr/>
              </p:nvGrpSpPr>
              <p:grpSpPr>
                <a:xfrm>
                  <a:off x="-1015314" y="5801105"/>
                  <a:ext cx="1663403" cy="1871582"/>
                  <a:chOff x="908440" y="6885309"/>
                  <a:chExt cx="1570430" cy="1778325"/>
                </a:xfrm>
              </p:grpSpPr>
              <p:pic>
                <p:nvPicPr>
                  <p:cNvPr id="38" name="Picture 3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7" cstate="screen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 bwMode="auto">
                  <a:xfrm>
                    <a:off x="908440" y="6885309"/>
                    <a:ext cx="1570430" cy="17783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41" name="Text Box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529941" y="7710488"/>
                    <a:ext cx="245401" cy="162032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marL="0" marR="0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sz="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26" name="Group 25"/>
                <p:cNvGrpSpPr/>
                <p:nvPr/>
              </p:nvGrpSpPr>
              <p:grpSpPr>
                <a:xfrm>
                  <a:off x="-1075017" y="4031509"/>
                  <a:ext cx="1723302" cy="1610476"/>
                  <a:chOff x="-1194352" y="1142811"/>
                  <a:chExt cx="1874345" cy="1976146"/>
                </a:xfrm>
              </p:grpSpPr>
              <p:grpSp>
                <p:nvGrpSpPr>
                  <p:cNvPr id="32" name="Group 31"/>
                  <p:cNvGrpSpPr/>
                  <p:nvPr/>
                </p:nvGrpSpPr>
                <p:grpSpPr>
                  <a:xfrm>
                    <a:off x="-1194352" y="1142811"/>
                    <a:ext cx="1874345" cy="1976146"/>
                    <a:chOff x="-1194352" y="1142811"/>
                    <a:chExt cx="1874345" cy="1976146"/>
                  </a:xfrm>
                </p:grpSpPr>
                <p:grpSp>
                  <p:nvGrpSpPr>
                    <p:cNvPr id="34" name="Group 33"/>
                    <p:cNvGrpSpPr/>
                    <p:nvPr/>
                  </p:nvGrpSpPr>
                  <p:grpSpPr>
                    <a:xfrm>
                      <a:off x="-1194352" y="1142811"/>
                      <a:ext cx="1874345" cy="1976146"/>
                      <a:chOff x="-1194352" y="1142811"/>
                      <a:chExt cx="1874345" cy="1976146"/>
                    </a:xfrm>
                  </p:grpSpPr>
                  <p:pic>
                    <p:nvPicPr>
                      <p:cNvPr id="36" name="Picture 35" descr="C:\Users\MA25302\Documents\LNCaP-pGIPz_array samples_PSA.tif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8" cstate="screen">
                        <a:extLst>
                          <a:ext uri="{28A0092B-C50C-407E-A947-70E740481C1C}">
                            <a14:useLocalDpi xmlns:a14="http://schemas.microsoft.com/office/drawing/2010/main"/>
                          </a:ext>
                        </a:extLst>
                      </a:blip>
                      <a:srcRect t="9018" r="23898" b="12390"/>
                      <a:stretch/>
                    </p:blipFill>
                    <p:spPr bwMode="auto">
                      <a:xfrm>
                        <a:off x="-1194352" y="1142811"/>
                        <a:ext cx="1874345" cy="1976146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extLst/>
                    </p:spPr>
                  </p:pic>
                  <p:sp>
                    <p:nvSpPr>
                      <p:cNvPr id="37" name="Text Box 2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01583" y="1339558"/>
                        <a:ext cx="179766" cy="23939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 marL="0" marR="0">
                          <a:lnSpc>
                            <a:spcPct val="107000"/>
                          </a:lnSpc>
                          <a:spcBef>
                            <a:spcPts val="0"/>
                          </a:spcBef>
                          <a:spcAft>
                            <a:spcPts val="800"/>
                          </a:spcAft>
                        </a:pPr>
                        <a:r>
                          <a:rPr lang="en-US" sz="600" dirty="0">
                            <a:effectLst/>
                            <a:latin typeface="Arial" panose="020B0604020202020204" pitchFamily="34" charset="0"/>
                            <a:ea typeface="Times New Roman" panose="02020603050405020304" pitchFamily="18" charset="0"/>
                            <a:cs typeface="Arial" panose="020B0604020202020204" pitchFamily="34" charset="0"/>
                          </a:rPr>
                          <a:t>*</a:t>
                        </a:r>
                      </a:p>
                    </p:txBody>
                  </p:sp>
                </p:grpSp>
                <p:sp>
                  <p:nvSpPr>
                    <p:cNvPr id="35" name="Text Box 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7897" y="2031701"/>
                      <a:ext cx="239395" cy="239396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6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</p:grpSp>
              <p:sp>
                <p:nvSpPr>
                  <p:cNvPr id="33" name="Text Box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397856" y="2112988"/>
                    <a:ext cx="239395" cy="239396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marL="0" marR="0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sz="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27" name="TextBox 26"/>
                <p:cNvSpPr txBox="1"/>
                <p:nvPr/>
              </p:nvSpPr>
              <p:spPr>
                <a:xfrm>
                  <a:off x="-320310" y="3961352"/>
                  <a:ext cx="676921" cy="2685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LK3</a:t>
                  </a:r>
                  <a:endParaRPr 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-489563" y="5759100"/>
                  <a:ext cx="1095995" cy="2685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PRSS2</a:t>
                  </a:r>
                  <a:endParaRPr lang="en-US" sz="11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331990" y="6008695"/>
                  <a:ext cx="165279" cy="195096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600" dirty="0"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30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431690" y="4180568"/>
                  <a:ext cx="53048" cy="207452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500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#</a:t>
                  </a:r>
                  <a:endParaRPr lang="en-US" sz="500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81652" y="6069024"/>
                  <a:ext cx="165279" cy="195096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600" dirty="0">
                      <a:effectLst/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pic>
            <p:nvPicPr>
              <p:cNvPr id="24" name="Picture 3"/>
              <p:cNvPicPr>
                <a:picLocks noChangeAspect="1" noChangeArrowheads="1"/>
              </p:cNvPicPr>
              <p:nvPr/>
            </p:nvPicPr>
            <p:blipFill rotWithShape="1">
              <a:blip r:embed="rId9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427206" y="7724253"/>
                <a:ext cx="185287" cy="2855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1" name="TextBox 20"/>
            <p:cNvSpPr txBox="1"/>
            <p:nvPr/>
          </p:nvSpPr>
          <p:spPr>
            <a:xfrm>
              <a:off x="9185100" y="5304825"/>
              <a:ext cx="3658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shCTL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189532" y="5405529"/>
              <a:ext cx="4395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shRARG</a:t>
              </a: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2504797" y="5136463"/>
            <a:ext cx="1430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446089" y="5138822"/>
            <a:ext cx="1430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9996" y="5210024"/>
            <a:ext cx="1717045" cy="3368632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1658823" y="5606787"/>
            <a:ext cx="860674" cy="1245957"/>
            <a:chOff x="-608605" y="8851796"/>
            <a:chExt cx="1012254" cy="1394810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505665" y="8972777"/>
              <a:ext cx="909314" cy="1273829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-608605" y="8851796"/>
              <a:ext cx="31771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NES</a:t>
              </a:r>
            </a:p>
          </p:txBody>
        </p:sp>
      </p:grpSp>
      <p:sp>
        <p:nvSpPr>
          <p:cNvPr id="53" name="Rectangle 52"/>
          <p:cNvSpPr/>
          <p:nvPr/>
        </p:nvSpPr>
        <p:spPr>
          <a:xfrm>
            <a:off x="2007893" y="5725815"/>
            <a:ext cx="514216" cy="10924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/>
          <p:cNvSpPr txBox="1"/>
          <p:nvPr/>
        </p:nvSpPr>
        <p:spPr>
          <a:xfrm>
            <a:off x="1931750" y="5762242"/>
            <a:ext cx="944489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RARG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 / </a:t>
            </a:r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934629" y="5845022"/>
            <a:ext cx="901209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shCTL-CD437 / </a:t>
            </a:r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</p:txBody>
      </p:sp>
      <p:sp>
        <p:nvSpPr>
          <p:cNvPr id="6" name="Rectangle 5"/>
          <p:cNvSpPr/>
          <p:nvPr/>
        </p:nvSpPr>
        <p:spPr>
          <a:xfrm>
            <a:off x="1918294" y="5724671"/>
            <a:ext cx="204745" cy="804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1911273" y="6018497"/>
            <a:ext cx="204745" cy="804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1924225" y="6076551"/>
            <a:ext cx="603050" cy="7643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HDAC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NFKB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INFLAMMATORY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RAR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TRETINOIN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</a:p>
          <a:p>
            <a:pPr>
              <a:spcAft>
                <a:spcPts val="18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325863" y="5158926"/>
            <a:ext cx="270140" cy="1512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NES</a:t>
            </a:r>
          </a:p>
        </p:txBody>
      </p:sp>
      <p:sp>
        <p:nvSpPr>
          <p:cNvPr id="59" name="Rectangle 58"/>
          <p:cNvSpPr/>
          <p:nvPr/>
        </p:nvSpPr>
        <p:spPr>
          <a:xfrm>
            <a:off x="4619862" y="5255507"/>
            <a:ext cx="514216" cy="7583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4535508" y="5291112"/>
            <a:ext cx="944489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RARG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 / </a:t>
            </a:r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538387" y="5373892"/>
            <a:ext cx="901209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shCTL-CD437 / </a:t>
            </a:r>
            <a:r>
              <a:rPr lang="en-US" sz="400" b="1" dirty="0" err="1">
                <a:latin typeface="Arial" panose="020B0604020202020204" pitchFamily="34" charset="0"/>
                <a:cs typeface="Arial" panose="020B0604020202020204" pitchFamily="34" charset="0"/>
              </a:rPr>
              <a:t>shCTL</a:t>
            </a: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</p:txBody>
      </p:sp>
      <p:sp>
        <p:nvSpPr>
          <p:cNvPr id="60" name="Rectangle 59"/>
          <p:cNvSpPr/>
          <p:nvPr/>
        </p:nvSpPr>
        <p:spPr>
          <a:xfrm>
            <a:off x="4537847" y="5274429"/>
            <a:ext cx="171950" cy="655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4530745" y="5514628"/>
            <a:ext cx="216745" cy="655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/>
          <p:cNvSpPr txBox="1"/>
          <p:nvPr/>
        </p:nvSpPr>
        <p:spPr>
          <a:xfrm>
            <a:off x="1830989" y="5971918"/>
            <a:ext cx="4539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Keyword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448444" y="5456672"/>
            <a:ext cx="45397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Keyword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542188" y="5542793"/>
            <a:ext cx="514885" cy="5257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ANDROGEN</a:t>
            </a:r>
          </a:p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BASAL</a:t>
            </a:r>
          </a:p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HIF</a:t>
            </a:r>
          </a:p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LUMINAL</a:t>
            </a:r>
          </a:p>
          <a:p>
            <a:pPr>
              <a:spcAft>
                <a:spcPts val="120"/>
              </a:spcAft>
            </a:pPr>
            <a:r>
              <a:rPr lang="en-US" sz="400" b="1" dirty="0">
                <a:latin typeface="Arial" panose="020B0604020202020204" pitchFamily="34" charset="0"/>
                <a:cs typeface="Arial" panose="020B0604020202020204" pitchFamily="34" charset="0"/>
              </a:rPr>
              <a:t>NEOPLASTIC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09266" y="2993703"/>
            <a:ext cx="958582" cy="310929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>
          <a:xfrm>
            <a:off x="4711269" y="3295574"/>
            <a:ext cx="1473657" cy="1335024"/>
          </a:xfrm>
          <a:prstGeom prst="ellips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57</a:t>
            </a:r>
          </a:p>
        </p:txBody>
      </p:sp>
      <p:sp>
        <p:nvSpPr>
          <p:cNvPr id="66" name="Oval 65"/>
          <p:cNvSpPr/>
          <p:nvPr/>
        </p:nvSpPr>
        <p:spPr>
          <a:xfrm>
            <a:off x="6328287" y="3952735"/>
            <a:ext cx="251819" cy="228793"/>
          </a:xfrm>
          <a:prstGeom prst="ellipse">
            <a:avLst/>
          </a:prstGeom>
          <a:solidFill>
            <a:srgbClr val="B56A53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>
                <a:solidFill>
                  <a:schemeClr val="tx1"/>
                </a:solidFill>
              </a:rPr>
              <a:t>1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97295" y="3248433"/>
            <a:ext cx="853737" cy="2655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5536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7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527031" y="195297"/>
            <a:ext cx="4174963" cy="32542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4028266"/>
            <a:ext cx="2755631" cy="157290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41305"/>
            <a:ext cx="2420795" cy="298063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2127" y="195297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00780" y="190691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0818" y="363796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377236" y="860916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1749987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73501" y="8744122"/>
            <a:ext cx="2710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4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16319" y="919778"/>
            <a:ext cx="2116154" cy="158711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38760" y="6054711"/>
            <a:ext cx="2893713" cy="217028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003816" y="3244303"/>
            <a:ext cx="2828657" cy="212149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8829" y="3074515"/>
            <a:ext cx="2768703" cy="246107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90255" y="933640"/>
            <a:ext cx="2097277" cy="157295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06617" y="919778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6617" y="3244303"/>
            <a:ext cx="309701" cy="3000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29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C:\Users\MA25302\Downloads\HPr1AR-shRARG_10nMDHT_qRT-PCR.tif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50000"/>
          <a:stretch/>
        </p:blipFill>
        <p:spPr bwMode="auto">
          <a:xfrm>
            <a:off x="21601" y="4535792"/>
            <a:ext cx="3415720" cy="15705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" name="Picture 4"/>
          <p:cNvPicPr>
            <a:picLocks noChangeAspect="1" noChangeArrowheads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584"/>
          <a:stretch/>
        </p:blipFill>
        <p:spPr bwMode="auto">
          <a:xfrm>
            <a:off x="3286751" y="2332894"/>
            <a:ext cx="1533692" cy="19483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/>
          <p:cNvGrpSpPr/>
          <p:nvPr/>
        </p:nvGrpSpPr>
        <p:grpSpPr>
          <a:xfrm>
            <a:off x="373354" y="2914213"/>
            <a:ext cx="2800795" cy="1327422"/>
            <a:chOff x="6855034" y="4517452"/>
            <a:chExt cx="2800795" cy="1327422"/>
          </a:xfrm>
        </p:grpSpPr>
        <p:pic>
          <p:nvPicPr>
            <p:cNvPr id="100" name="Picture 2" descr="\\CancerGenetics\CG$\SmiragliaLab\Mark Long\Projects\RARg and miR-96-182-183\HPr1AR\WesternBlots\HPr1AR-shRARG_DHT_R4_020217\Long, Mark 2017-02-02 11hr 17min-1_Exposure_560.0sec+colorimteric.jpg"/>
            <p:cNvPicPr>
              <a:picLocks noChangeAspect="1" noChangeArrowheads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7477684" y="4517452"/>
              <a:ext cx="2178145" cy="25204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" name="Picture 3" descr="W:\Chemi-Doc\HPr1AR-shRARG_DHT_R4_020217\bActin\Long, Mark 2017-02-02 16hr 45min_Exposure_20.0sec+colorimetric.jpg"/>
            <p:cNvPicPr>
              <a:picLocks noChangeAspect="1" noChangeArrowheads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7477684" y="4845720"/>
              <a:ext cx="2178145" cy="2639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6" name="TextBox 2"/>
            <p:cNvSpPr txBox="1"/>
            <p:nvPr/>
          </p:nvSpPr>
          <p:spPr>
            <a:xfrm>
              <a:off x="6953552" y="4537810"/>
              <a:ext cx="808895" cy="3225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Calibri"/>
                  <a:ea typeface="Times New Roman"/>
                  <a:cs typeface="Times New Roman"/>
                </a:rPr>
                <a:t>RAR</a:t>
              </a:r>
              <a:r>
                <a:rPr lang="el-GR" sz="1000" b="1" dirty="0">
                  <a:solidFill>
                    <a:srgbClr val="000000"/>
                  </a:solidFill>
                  <a:latin typeface="Calibri"/>
                  <a:ea typeface="Times New Roman"/>
                  <a:cs typeface="Times New Roman"/>
                </a:rPr>
                <a:t>γ</a:t>
              </a:r>
              <a:endParaRPr lang="en-US" sz="1000" b="1" dirty="0">
                <a:latin typeface="Times New Roman"/>
                <a:ea typeface="Times New Roman"/>
              </a:endParaRPr>
            </a:p>
          </p:txBody>
        </p:sp>
        <p:sp>
          <p:nvSpPr>
            <p:cNvPr id="147" name="TextBox 14"/>
            <p:cNvSpPr txBox="1"/>
            <p:nvPr/>
          </p:nvSpPr>
          <p:spPr>
            <a:xfrm>
              <a:off x="6855034" y="4845720"/>
              <a:ext cx="973901" cy="3767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Calibri"/>
                  <a:ea typeface="Times New Roman"/>
                  <a:cs typeface="Times New Roman"/>
                </a:rPr>
                <a:t>GAPDH</a:t>
              </a:r>
              <a:endParaRPr lang="en-US" sz="1000" b="1" dirty="0">
                <a:latin typeface="Times New Roman"/>
                <a:ea typeface="Times New Roman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64282" y="5109641"/>
              <a:ext cx="2177081" cy="7352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48" name="TextBox 147"/>
          <p:cNvSpPr txBox="1"/>
          <p:nvPr/>
        </p:nvSpPr>
        <p:spPr>
          <a:xfrm>
            <a:off x="126998" y="2914213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152105" y="418696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pic>
        <p:nvPicPr>
          <p:cNvPr id="151" name="Picture 4" descr="C:\Users\MA25302\Downloads\HPr1AR-shRARG_10nMDHT_qRT-PCR.tif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0000"/>
          <a:stretch/>
        </p:blipFill>
        <p:spPr bwMode="auto">
          <a:xfrm>
            <a:off x="3381591" y="4569081"/>
            <a:ext cx="3415720" cy="1570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1954315" y="873377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5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45400" y="4382749"/>
            <a:ext cx="5943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RARG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351802" y="4382749"/>
            <a:ext cx="5943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DPP4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039219" y="4382749"/>
            <a:ext cx="5943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S100P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726636" y="4382749"/>
            <a:ext cx="7101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STEAP4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71" y="307188"/>
            <a:ext cx="6858000" cy="215315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88087" y="4644359"/>
            <a:ext cx="617174" cy="32469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0"/>
          <a:srcRect r="3798"/>
          <a:stretch/>
        </p:blipFill>
        <p:spPr>
          <a:xfrm>
            <a:off x="127325" y="6427433"/>
            <a:ext cx="6597570" cy="191249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81419" y="2417436"/>
            <a:ext cx="504268" cy="373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33592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46908" y="250508"/>
            <a:ext cx="2909492" cy="2508741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073784" y="85700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6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4622" y="13115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pic>
        <p:nvPicPr>
          <p:cNvPr id="24" name="Picture 3" descr="C:\Users\MA25302\Downloads\HPr1AR_RARG_DHT_RNAseq_PCA.tiff"/>
          <p:cNvPicPr>
            <a:picLocks noChangeAspect="1" noChangeArrowheads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16511" y="463856"/>
            <a:ext cx="3374917" cy="21256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3897326" y="13115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563"/>
          <a:stretch/>
        </p:blipFill>
        <p:spPr>
          <a:xfrm>
            <a:off x="3413890" y="3195828"/>
            <a:ext cx="3169790" cy="265155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82848" y="282575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7026" y="463856"/>
            <a:ext cx="655976" cy="244601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3560953" y="282575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701" t="6082" r="6610" b="6081"/>
          <a:stretch/>
        </p:blipFill>
        <p:spPr>
          <a:xfrm>
            <a:off x="640080" y="3078479"/>
            <a:ext cx="2255520" cy="23393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6800" y="2735906"/>
            <a:ext cx="1331026" cy="36116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58370" y="5417820"/>
            <a:ext cx="1239456" cy="40525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08722" y="3409301"/>
            <a:ext cx="602443" cy="9627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71251" y="3953239"/>
            <a:ext cx="539914" cy="836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6761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4366" y="5725022"/>
            <a:ext cx="5362054" cy="28775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4366" y="150887"/>
            <a:ext cx="5362054" cy="28775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4366" y="2937954"/>
            <a:ext cx="5362054" cy="287756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67539" y="8622904"/>
            <a:ext cx="2710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7 </a:t>
            </a:r>
          </a:p>
        </p:txBody>
      </p:sp>
    </p:spTree>
    <p:extLst>
      <p:ext uri="{BB962C8B-B14F-4D97-AF65-F5344CB8AC3E}">
        <p14:creationId xmlns:p14="http://schemas.microsoft.com/office/powerpoint/2010/main" val="4353801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16586" y="7413"/>
            <a:ext cx="6308435" cy="3748573"/>
            <a:chOff x="439215" y="46676"/>
            <a:chExt cx="6308793" cy="3748598"/>
          </a:xfrm>
        </p:grpSpPr>
        <p:sp>
          <p:nvSpPr>
            <p:cNvPr id="5" name="TextBox 5"/>
            <p:cNvSpPr txBox="1"/>
            <p:nvPr/>
          </p:nvSpPr>
          <p:spPr>
            <a:xfrm>
              <a:off x="6292356" y="355479"/>
              <a:ext cx="455652" cy="3439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1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06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3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7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1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13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6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9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7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4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3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8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3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9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0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9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6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10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4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4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5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76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2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1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2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2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9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" name="TextBox 7"/>
            <p:cNvSpPr txBox="1"/>
            <p:nvPr/>
          </p:nvSpPr>
          <p:spPr>
            <a:xfrm rot="16200000">
              <a:off x="-573610" y="2054151"/>
              <a:ext cx="2395855" cy="370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800" b="1" kern="1200" dirty="0"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NR Targeting microRN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" name="TextBox 8"/>
            <p:cNvSpPr txBox="1"/>
            <p:nvPr/>
          </p:nvSpPr>
          <p:spPr>
            <a:xfrm>
              <a:off x="4276047" y="61673"/>
              <a:ext cx="2290681" cy="339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kern="1200" dirty="0"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SKCC Cohort (n=78)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" name="TextBox 9"/>
            <p:cNvSpPr txBox="1"/>
            <p:nvPr/>
          </p:nvSpPr>
          <p:spPr>
            <a:xfrm>
              <a:off x="1232372" y="46676"/>
              <a:ext cx="2564765" cy="3397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600" b="1" kern="1200" dirty="0"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CGA PRAD Cohort (n = 492)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59079" y="4678176"/>
            <a:ext cx="5991225" cy="1647825"/>
            <a:chOff x="0" y="0"/>
            <a:chExt cx="6788413" cy="2019931"/>
          </a:xfrm>
        </p:grpSpPr>
        <p:pic>
          <p:nvPicPr>
            <p:cNvPr id="10" name="Picture 9"/>
            <p:cNvPicPr>
              <a:picLocks noChangeAspect="1" noChangeArrowheads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3423638" cy="19703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 noChangeArrowheads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3638" y="0"/>
              <a:ext cx="3364775" cy="20199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3086" name="Picture 1394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089899" y="316214"/>
            <a:ext cx="1954213" cy="3428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 Box 2"/>
          <p:cNvSpPr txBox="1">
            <a:spLocks noChangeArrowheads="1"/>
          </p:cNvSpPr>
          <p:nvPr/>
        </p:nvSpPr>
        <p:spPr bwMode="auto">
          <a:xfrm>
            <a:off x="5424730" y="4782170"/>
            <a:ext cx="1173162" cy="739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R targeting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NA = 8.74%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 = 0.023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2331299" y="4862180"/>
            <a:ext cx="1173162" cy="741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R targeting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NA = 8.76%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 = 0.72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430815" y="326559"/>
            <a:ext cx="3664183" cy="4177252"/>
            <a:chOff x="24512" y="-991"/>
            <a:chExt cx="4471288" cy="4828180"/>
          </a:xfrm>
        </p:grpSpPr>
        <p:pic>
          <p:nvPicPr>
            <p:cNvPr id="16" name="Picture 15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24512" y="-991"/>
              <a:ext cx="3990976" cy="44146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Rectangle 16"/>
            <p:cNvSpPr/>
            <p:nvPr/>
          </p:nvSpPr>
          <p:spPr>
            <a:xfrm>
              <a:off x="3914775" y="7539"/>
              <a:ext cx="581025" cy="481965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06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7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3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5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6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7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4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2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4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10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1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9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94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9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4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3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0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2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0e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9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5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7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5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1c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81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9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0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07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2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6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9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766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90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8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3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543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889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43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44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135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3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de-DE" sz="400" b="1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R-2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4" name="Rectangle 15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8" name="Rectangle 17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22"/>
          <p:cNvSpPr>
            <a:spLocks noChangeArrowheads="1"/>
          </p:cNvSpPr>
          <p:nvPr/>
        </p:nvSpPr>
        <p:spPr bwMode="auto">
          <a:xfrm>
            <a:off x="0" y="4595813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0" name="Rectangle 25"/>
          <p:cNvSpPr>
            <a:spLocks noChangeArrowheads="1"/>
          </p:cNvSpPr>
          <p:nvPr/>
        </p:nvSpPr>
        <p:spPr bwMode="auto">
          <a:xfrm>
            <a:off x="0" y="459581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057228" y="8319257"/>
            <a:ext cx="2646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8</a:t>
            </a:r>
          </a:p>
          <a:p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4622" y="13115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0435" y="4378093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387962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70334" y="3789948"/>
            <a:ext cx="5982017" cy="2341428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073784" y="8307257"/>
            <a:ext cx="2646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 9</a:t>
            </a:r>
          </a:p>
          <a:p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97057" y="410678"/>
            <a:ext cx="3412616" cy="284028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31369" y="131154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5859" y="332349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3214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576</TotalTime>
  <Words>935</Words>
  <Application>Microsoft Macintosh PowerPoint</Application>
  <PresentationFormat>Letter Paper (8.5x11 in)</PresentationFormat>
  <Paragraphs>372</Paragraphs>
  <Slides>18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5" baseType="lpstr">
      <vt:lpstr>Arial</vt:lpstr>
      <vt:lpstr>Calibri</vt:lpstr>
      <vt:lpstr>Calibri Light</vt:lpstr>
      <vt:lpstr>Symbol</vt:lpstr>
      <vt:lpstr>Times New Roman</vt:lpstr>
      <vt:lpstr>Office Theme</vt:lpstr>
      <vt:lpstr>Prism6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46</cp:revision>
  <dcterms:created xsi:type="dcterms:W3CDTF">2017-04-11T17:16:13Z</dcterms:created>
  <dcterms:modified xsi:type="dcterms:W3CDTF">2018-04-25T15:19:43Z</dcterms:modified>
</cp:coreProperties>
</file>